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2" r:id="rId2"/>
    <p:sldId id="265" r:id="rId3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12" y="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FEDCBF-19AE-4373-98D8-29F95E8D76BD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961121-1770-4864-899E-C45EE9D1D00C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617597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Movie 2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rphology changes of a single WT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PS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CM during the maturation induced by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trixPlus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pt-B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Movie 1 </a:t>
            </a:r>
            <a:r>
              <a:rPr lang="en-US" dirty="0"/>
              <a:t>Reprogramming of fibroblasts into </a:t>
            </a:r>
            <a:r>
              <a:rPr lang="en-US" dirty="0" err="1"/>
              <a:t>hiPSC</a:t>
            </a:r>
            <a:r>
              <a:rPr lang="en-US" dirty="0"/>
              <a:t>. Fibroblasts from a Fabry Disease patient were treated with  Sendai viruses carrying KOS, </a:t>
            </a:r>
            <a:r>
              <a:rPr lang="en-US" dirty="0" err="1"/>
              <a:t>hc</a:t>
            </a:r>
            <a:r>
              <a:rPr lang="en-US" dirty="0"/>
              <a:t>-MYC and KLF-4 were applied to human fibroblasts from a patient carrying a mutation causative of Fabry Disease began to form </a:t>
            </a:r>
            <a:r>
              <a:rPr lang="en-US" dirty="0" err="1"/>
              <a:t>hiPSC</a:t>
            </a:r>
            <a:r>
              <a:rPr lang="en-US" dirty="0"/>
              <a:t> colonies 10 days after reprogramming (yellow arrows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12AFB3-86D2-4519-8C9D-283DE176C9B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656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movie 3.</a:t>
            </a:r>
            <a:r>
              <a:rPr lang="en-US" dirty="0"/>
              <a:t> WT </a:t>
            </a:r>
            <a:r>
              <a:rPr lang="en-US" dirty="0" err="1"/>
              <a:t>hiPSC</a:t>
            </a:r>
            <a:r>
              <a:rPr lang="en-US" dirty="0"/>
              <a:t>-VCMs present regular rhythm of spontaneous activation in contrast with FD </a:t>
            </a:r>
            <a:r>
              <a:rPr lang="en-US" dirty="0" err="1"/>
              <a:t>hiPSC</a:t>
            </a:r>
            <a:r>
              <a:rPr lang="en-US" dirty="0"/>
              <a:t>-VCMs. 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T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PS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CMs present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movie 4.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PS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CMs with reentrant rhythms.</a:t>
            </a:r>
            <a:endParaRPr lang="pt-BR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 regular rhythm of spontaneous activation in contrast with FD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PS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CM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112AFB3-86D2-4519-8C9D-283DE176C9B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4412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8BECB-61DB-F589-51A0-45CF1609C5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910869-2879-EC3F-2012-185AB9DB66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pt-B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9FA8C-8DBA-5B41-39A4-EF8F00257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E3F932-2718-4A6D-3FBC-520724547D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D5B873-A0AA-90FC-9350-59265E8D7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80262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97B700-1B17-B059-D97D-565A46B200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9BC098-3C8C-AE7E-FB74-D72A15C036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D169B4-4DBE-7F19-E83E-5F7F5AE16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FA818A-5264-E775-7762-8EE161E50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FFABB-2F5C-DD6F-7BE7-EDECE709D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74277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0109918-B549-EEC9-86CA-2C5F0E9472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BA31597-C259-4E7E-CAA8-75A287A411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8FCF30-ED44-BC45-02E2-E89AAFE41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22B42-7535-C2FF-AEDC-C3ECA5F41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9F1CD0-572C-2297-24F9-236BEE438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943651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06C09F-B0FB-53AB-D1AE-7E9F3B9F68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3DFF7B-3B9A-2E09-2999-8238B2B3C5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7E504A-FBE6-9D28-AE61-AF9BD15E2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AB9E3-EC0D-E968-9221-255B31770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EC6AD7-1340-0F57-B238-6905579E1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83131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3B5880-155F-77C7-359B-78A143192D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CBE1AE-659D-A2FF-2FF9-6AA08A9E08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67F08F-2343-9227-BAE0-C1B120B49F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5B73FF-B8E7-5F49-54D6-B56E6B393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35E2F4-BB1F-0D30-EE2A-687A81942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51810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7F54F1-601A-7DC6-FAE2-4D0591CC8D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6A31BD-64F6-23A2-1857-6FDB1B4588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D62CA4-E914-A462-FFA9-9958EFCFD3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596132-E663-404F-2A13-91A03B5C4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403F55-7F75-DE2C-1381-ED282B8FC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6BBC6F-6385-95A4-E7F1-9C2193C85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34462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E66D8-0AE3-0897-D811-1FD856B13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E50457-3A93-8E3C-EA43-3995DF31EA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7DA657-FF9A-4966-9D3B-7E9668BECD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59B8F4-1E49-C554-A780-73B474AA23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D8B6B3-B555-4CCF-3993-82C3EA68E0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D75859-4512-2BC6-AB39-66C0B49877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6E5934F-E2A0-EF9C-740F-FDBDEB3FE7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24E8A0F-F499-B834-B180-66232748F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37242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4D6D83-E42E-DA01-6C8E-3ED48061A1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C66E4A8-A287-136C-3F6A-B8A2F425F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AF8C42-C540-98B8-4584-960DEC281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1CC0BBB-77DA-02B6-085E-7E7AFBF03A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77797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CA41F3-B2B5-7103-EE24-291620CC8C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43E9F21-FE4A-74A7-47F4-C045991AF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30C4181-ECE8-3D45-85BA-22C5A4015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71931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EE30BF-0330-FD8D-4401-E065511C79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77592A-9DC8-CB92-CDF6-1C5DB94EED3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8D11E5-D128-5B4F-965A-3149C0A1AC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A6C352-56D6-D91D-752B-09E6B3FDE0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9EEAA1-8FD0-65A4-C9A2-7E3334D5F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ADD08F-724D-0B1F-B99B-0782596B1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07433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D9CBF5-0945-2FA5-3A80-FAC9506299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14B2335-75B3-25C1-BBFE-CD46742829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75B1BA-A145-09B0-64CE-DD81AA41F1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C439CD-59CE-91F1-5134-81C272689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B46CEE-EB4D-478F-32AD-F517641F8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57E9DA-4FB1-6DDB-E766-356E602522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75329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8642277-FFA6-49A5-F0F9-E5D7D09434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pt-B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65B492-EA92-4B7B-F148-CFDE6FDC82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B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F76242-B56C-77A5-D91B-4F8AA4A246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07A6CED-7E48-430E-8D7C-243A17718E4A}" type="datetimeFigureOut">
              <a:rPr lang="pt-BR" smtClean="0"/>
              <a:t>18/02/2026</a:t>
            </a:fld>
            <a:endParaRPr lang="pt-B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9D8DB7-8118-B6A3-5B6C-853974199C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21AC14-5088-355D-D231-15754B26F2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4EF471E-2D8C-4BFA-AFED-3FB07B0F3CF7}" type="slidenum">
              <a:rPr lang="pt-BR" smtClean="0"/>
              <a:t>‹#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034820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2.mp4"/><Relationship Id="rId7" Type="http://schemas.openxmlformats.org/officeDocument/2006/relationships/image" Target="../media/image1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notesSlide" Target="../notesSlides/notesSlide1.xml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mp4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media" Target="../media/media4.mp4"/><Relationship Id="rId7" Type="http://schemas.openxmlformats.org/officeDocument/2006/relationships/image" Target="../media/image3.png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6" Type="http://schemas.openxmlformats.org/officeDocument/2006/relationships/notesSlide" Target="../notesSlides/notesSlide2.xml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4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B06C6C0-76AA-848C-CBBE-330880091156}"/>
              </a:ext>
            </a:extLst>
          </p:cNvPr>
          <p:cNvSpPr txBox="1"/>
          <p:nvPr/>
        </p:nvSpPr>
        <p:spPr>
          <a:xfrm>
            <a:off x="3489347" y="6660144"/>
            <a:ext cx="1446230" cy="2407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64" dirty="0"/>
              <a:t>Supplementary movie 2</a:t>
            </a:r>
          </a:p>
        </p:txBody>
      </p:sp>
      <p:pic>
        <p:nvPicPr>
          <p:cNvPr id="5" name="liming reprogramming 122120_B2_1">
            <a:hlinkClick r:id="" action="ppaction://media"/>
            <a:extLst>
              <a:ext uri="{FF2B5EF4-FFF2-40B4-BE49-F238E27FC236}">
                <a16:creationId xmlns:a16="http://schemas.microsoft.com/office/drawing/2014/main" id="{48F752B8-DA1C-9D30-7FFB-39F3960EBDB1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3321694" y="124606"/>
            <a:ext cx="4932355" cy="3036063"/>
          </a:xfrm>
        </p:spPr>
      </p:pic>
      <p:sp>
        <p:nvSpPr>
          <p:cNvPr id="7" name="Arrow: Right 6">
            <a:extLst>
              <a:ext uri="{FF2B5EF4-FFF2-40B4-BE49-F238E27FC236}">
                <a16:creationId xmlns:a16="http://schemas.microsoft.com/office/drawing/2014/main" id="{D5E8E4E5-211B-814A-C5F3-A2BFF52CFF88}"/>
              </a:ext>
            </a:extLst>
          </p:cNvPr>
          <p:cNvSpPr/>
          <p:nvPr/>
        </p:nvSpPr>
        <p:spPr>
          <a:xfrm rot="19439570">
            <a:off x="5363535" y="1663562"/>
            <a:ext cx="310788" cy="242113"/>
          </a:xfrm>
          <a:prstGeom prst="rightArrow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4"/>
          </a:p>
        </p:txBody>
      </p:sp>
      <p:sp>
        <p:nvSpPr>
          <p:cNvPr id="9" name="Arrow: Right 8">
            <a:extLst>
              <a:ext uri="{FF2B5EF4-FFF2-40B4-BE49-F238E27FC236}">
                <a16:creationId xmlns:a16="http://schemas.microsoft.com/office/drawing/2014/main" id="{9681834C-7E63-B79E-5699-E148D9229DF7}"/>
              </a:ext>
            </a:extLst>
          </p:cNvPr>
          <p:cNvSpPr/>
          <p:nvPr/>
        </p:nvSpPr>
        <p:spPr>
          <a:xfrm rot="2656073">
            <a:off x="5436702" y="471621"/>
            <a:ext cx="310788" cy="242113"/>
          </a:xfrm>
          <a:prstGeom prst="rightArrow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4"/>
          </a:p>
        </p:txBody>
      </p:sp>
      <p:sp>
        <p:nvSpPr>
          <p:cNvPr id="10" name="Arrow: Right 9">
            <a:extLst>
              <a:ext uri="{FF2B5EF4-FFF2-40B4-BE49-F238E27FC236}">
                <a16:creationId xmlns:a16="http://schemas.microsoft.com/office/drawing/2014/main" id="{FA480670-DD35-FEA8-711C-A699DDEC7F0B}"/>
              </a:ext>
            </a:extLst>
          </p:cNvPr>
          <p:cNvSpPr/>
          <p:nvPr/>
        </p:nvSpPr>
        <p:spPr>
          <a:xfrm rot="7582638">
            <a:off x="6742832" y="1792160"/>
            <a:ext cx="310788" cy="242113"/>
          </a:xfrm>
          <a:prstGeom prst="rightArrow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4"/>
          </a:p>
        </p:txBody>
      </p:sp>
      <p:sp>
        <p:nvSpPr>
          <p:cNvPr id="11" name="Arrow: Right 10">
            <a:extLst>
              <a:ext uri="{FF2B5EF4-FFF2-40B4-BE49-F238E27FC236}">
                <a16:creationId xmlns:a16="http://schemas.microsoft.com/office/drawing/2014/main" id="{476C3732-0FB6-DF48-A004-ACC592D34346}"/>
              </a:ext>
            </a:extLst>
          </p:cNvPr>
          <p:cNvSpPr/>
          <p:nvPr/>
        </p:nvSpPr>
        <p:spPr>
          <a:xfrm rot="1530270">
            <a:off x="4624500" y="1002036"/>
            <a:ext cx="310788" cy="242113"/>
          </a:xfrm>
          <a:prstGeom prst="rightArrow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64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03DF8B1-FD77-207E-9005-0A947A34FB17}"/>
              </a:ext>
            </a:extLst>
          </p:cNvPr>
          <p:cNvSpPr txBox="1"/>
          <p:nvPr/>
        </p:nvSpPr>
        <p:spPr>
          <a:xfrm>
            <a:off x="3577067" y="3160669"/>
            <a:ext cx="2585061" cy="2407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64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movie 1. </a:t>
            </a:r>
            <a:endParaRPr lang="pt-BR" sz="964" dirty="0"/>
          </a:p>
        </p:txBody>
      </p:sp>
      <p:pic>
        <p:nvPicPr>
          <p:cNvPr id="8" name="168  rodshaped_A7_6">
            <a:hlinkClick r:id="" action="ppaction://media"/>
            <a:extLst>
              <a:ext uri="{FF2B5EF4-FFF2-40B4-BE49-F238E27FC236}">
                <a16:creationId xmlns:a16="http://schemas.microsoft.com/office/drawing/2014/main" id="{351B80A4-1343-0C09-DB64-94755881FB30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3445441" y="4752368"/>
            <a:ext cx="3263154" cy="18759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693474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5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3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4" fill="hold">
                      <p:stCondLst>
                        <p:cond delay="0"/>
                      </p:stCondLst>
                      <p:childTnLst>
                        <p:par>
                          <p:cTn id="15" fill="hold">
                            <p:stCondLst>
                              <p:cond delay="0"/>
                            </p:stCondLst>
                            <p:childTnLst>
                              <p:par>
                                <p:cTn id="1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7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18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re-eliglustat">
            <a:hlinkClick r:id="" action="ppaction://media"/>
            <a:extLst>
              <a:ext uri="{FF2B5EF4-FFF2-40B4-BE49-F238E27FC236}">
                <a16:creationId xmlns:a16="http://schemas.microsoft.com/office/drawing/2014/main" id="{64025650-7B3D-D30F-37E4-18E6048160E3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427266" y="2153572"/>
            <a:ext cx="2560244" cy="2560244"/>
          </a:xfr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6281163E-A1CD-B37D-5EED-109A74DE30E8}"/>
              </a:ext>
            </a:extLst>
          </p:cNvPr>
          <p:cNvSpPr txBox="1"/>
          <p:nvPr/>
        </p:nvSpPr>
        <p:spPr>
          <a:xfrm>
            <a:off x="3533553" y="2684780"/>
            <a:ext cx="335348" cy="3561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14" dirty="0"/>
              <a:t>D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1A621B64-2224-D984-1885-8344D9CECF75}"/>
              </a:ext>
            </a:extLst>
          </p:cNvPr>
          <p:cNvGrpSpPr/>
          <p:nvPr/>
        </p:nvGrpSpPr>
        <p:grpSpPr>
          <a:xfrm>
            <a:off x="2183508" y="1374304"/>
            <a:ext cx="2740866" cy="3276101"/>
            <a:chOff x="-145592" y="1018816"/>
            <a:chExt cx="5116282" cy="6115389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6CFFC15-47AD-38D7-3AD7-DA04FF5D6DC8}"/>
                </a:ext>
              </a:extLst>
            </p:cNvPr>
            <p:cNvSpPr txBox="1"/>
            <p:nvPr/>
          </p:nvSpPr>
          <p:spPr>
            <a:xfrm>
              <a:off x="-143613" y="3393442"/>
              <a:ext cx="593070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B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3BC622E-38E8-A165-642E-85D85988A920}"/>
                </a:ext>
              </a:extLst>
            </p:cNvPr>
            <p:cNvSpPr txBox="1"/>
            <p:nvPr/>
          </p:nvSpPr>
          <p:spPr>
            <a:xfrm>
              <a:off x="-145592" y="2578845"/>
              <a:ext cx="587085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FA1B6C3-F202-D8F8-D7D6-4BFB851CD537}"/>
                </a:ext>
              </a:extLst>
            </p:cNvPr>
            <p:cNvSpPr txBox="1"/>
            <p:nvPr/>
          </p:nvSpPr>
          <p:spPr>
            <a:xfrm>
              <a:off x="-134138" y="4292235"/>
              <a:ext cx="62897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C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C7A31FB-A703-41B6-90BF-DDEB6D3FA315}"/>
                </a:ext>
              </a:extLst>
            </p:cNvPr>
            <p:cNvSpPr txBox="1"/>
            <p:nvPr/>
          </p:nvSpPr>
          <p:spPr>
            <a:xfrm>
              <a:off x="-138405" y="6469442"/>
              <a:ext cx="560153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F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0298299-6412-2B6C-FB62-608096C5D75C}"/>
                </a:ext>
              </a:extLst>
            </p:cNvPr>
            <p:cNvSpPr txBox="1"/>
            <p:nvPr/>
          </p:nvSpPr>
          <p:spPr>
            <a:xfrm>
              <a:off x="-140384" y="5654845"/>
              <a:ext cx="572122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E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790ABDC-FBF8-1E82-B011-6B0B8984903C}"/>
                </a:ext>
              </a:extLst>
            </p:cNvPr>
            <p:cNvSpPr txBox="1"/>
            <p:nvPr/>
          </p:nvSpPr>
          <p:spPr>
            <a:xfrm>
              <a:off x="399646" y="1946325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8BB37A4-F7CD-74D0-A901-628ED9829120}"/>
                </a:ext>
              </a:extLst>
            </p:cNvPr>
            <p:cNvSpPr txBox="1"/>
            <p:nvPr/>
          </p:nvSpPr>
          <p:spPr>
            <a:xfrm>
              <a:off x="1199485" y="1959215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2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E68A29A-EA13-383A-FDA3-619312427D85}"/>
                </a:ext>
              </a:extLst>
            </p:cNvPr>
            <p:cNvSpPr txBox="1"/>
            <p:nvPr/>
          </p:nvSpPr>
          <p:spPr>
            <a:xfrm>
              <a:off x="1987013" y="1946325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3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3EC7CB5-5B17-6B28-91DD-9270FE9BE274}"/>
                </a:ext>
              </a:extLst>
            </p:cNvPr>
            <p:cNvSpPr txBox="1"/>
            <p:nvPr/>
          </p:nvSpPr>
          <p:spPr>
            <a:xfrm>
              <a:off x="2774539" y="1946325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4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F7AF535A-0F08-047A-16F9-A33CED94E4C3}"/>
                </a:ext>
              </a:extLst>
            </p:cNvPr>
            <p:cNvSpPr txBox="1"/>
            <p:nvPr/>
          </p:nvSpPr>
          <p:spPr>
            <a:xfrm>
              <a:off x="3620017" y="1939594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0BD5A13-CFE8-77CB-700E-6B0955E70320}"/>
                </a:ext>
              </a:extLst>
            </p:cNvPr>
            <p:cNvSpPr txBox="1"/>
            <p:nvPr/>
          </p:nvSpPr>
          <p:spPr>
            <a:xfrm>
              <a:off x="4407543" y="1939594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6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C9B7B0F-470E-7EFD-8E62-9E76B884EB1D}"/>
                </a:ext>
              </a:extLst>
            </p:cNvPr>
            <p:cNvSpPr txBox="1"/>
            <p:nvPr/>
          </p:nvSpPr>
          <p:spPr>
            <a:xfrm>
              <a:off x="388256" y="1018816"/>
              <a:ext cx="4495709" cy="11571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14" dirty="0"/>
                <a:t>Supplementary Movie 3</a:t>
              </a:r>
            </a:p>
            <a:p>
              <a:pPr algn="ctr"/>
              <a:r>
                <a:rPr lang="en-US" sz="1714" dirty="0"/>
                <a:t> WT hiPSC-VCM</a:t>
              </a: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52FBEE62-A4F1-F488-5599-3FDDC00A2808}"/>
              </a:ext>
            </a:extLst>
          </p:cNvPr>
          <p:cNvGrpSpPr/>
          <p:nvPr/>
        </p:nvGrpSpPr>
        <p:grpSpPr>
          <a:xfrm>
            <a:off x="6786694" y="1799634"/>
            <a:ext cx="2408416" cy="2497295"/>
            <a:chOff x="5206892" y="2076646"/>
            <a:chExt cx="4495705" cy="4661615"/>
          </a:xfrm>
        </p:grpSpPr>
        <p:pic>
          <p:nvPicPr>
            <p:cNvPr id="6" name="JSF0 01 032321">
              <a:hlinkClick r:id="" action="ppaction://media"/>
              <a:extLst>
                <a:ext uri="{FF2B5EF4-FFF2-40B4-BE49-F238E27FC236}">
                  <a16:creationId xmlns:a16="http://schemas.microsoft.com/office/drawing/2014/main" id="{36074302-AC79-4E79-39D3-CF5500D5D49A}"/>
                </a:ext>
              </a:extLst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 rotWithShape="1">
            <a:blip r:embed="rId8">
              <a:lum bright="16000" contrast="46000"/>
            </a:blip>
            <a:srcRect t="31559" r="29131"/>
            <a:stretch/>
          </p:blipFill>
          <p:spPr>
            <a:xfrm>
              <a:off x="5803680" y="3549247"/>
              <a:ext cx="3302129" cy="3189014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A4A60CE-C48B-14B8-5720-F918C9658646}"/>
                </a:ext>
              </a:extLst>
            </p:cNvPr>
            <p:cNvSpPr txBox="1"/>
            <p:nvPr/>
          </p:nvSpPr>
          <p:spPr>
            <a:xfrm>
              <a:off x="5319536" y="4376160"/>
              <a:ext cx="593070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B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8171EB9-A73B-9F22-EADC-952985E7C84B}"/>
                </a:ext>
              </a:extLst>
            </p:cNvPr>
            <p:cNvSpPr txBox="1"/>
            <p:nvPr/>
          </p:nvSpPr>
          <p:spPr>
            <a:xfrm>
              <a:off x="5317555" y="3561563"/>
              <a:ext cx="587085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06BA807-FF36-5CB2-F1DC-F205852E2251}"/>
                </a:ext>
              </a:extLst>
            </p:cNvPr>
            <p:cNvSpPr txBox="1"/>
            <p:nvPr/>
          </p:nvSpPr>
          <p:spPr>
            <a:xfrm>
              <a:off x="5329011" y="5274950"/>
              <a:ext cx="62897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C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A487649-FFB9-ED3F-9CF9-59F1752F9FDD}"/>
                </a:ext>
              </a:extLst>
            </p:cNvPr>
            <p:cNvSpPr txBox="1"/>
            <p:nvPr/>
          </p:nvSpPr>
          <p:spPr>
            <a:xfrm>
              <a:off x="5312349" y="5983794"/>
              <a:ext cx="625983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2E54A70-FA7C-B500-5D35-65E1FA9EB2EE}"/>
                </a:ext>
              </a:extLst>
            </p:cNvPr>
            <p:cNvSpPr txBox="1"/>
            <p:nvPr/>
          </p:nvSpPr>
          <p:spPr>
            <a:xfrm>
              <a:off x="5961269" y="2994478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1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D43DA33-84B2-123A-94AD-C93A4E0C7BF3}"/>
                </a:ext>
              </a:extLst>
            </p:cNvPr>
            <p:cNvSpPr txBox="1"/>
            <p:nvPr/>
          </p:nvSpPr>
          <p:spPr>
            <a:xfrm>
              <a:off x="6761108" y="3007367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75F880E-ECB5-11BB-E4F6-256653167A2F}"/>
                </a:ext>
              </a:extLst>
            </p:cNvPr>
            <p:cNvSpPr txBox="1"/>
            <p:nvPr/>
          </p:nvSpPr>
          <p:spPr>
            <a:xfrm>
              <a:off x="7548634" y="2994478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760F1C5-C0DF-7AEC-81AB-22B9FC07B3E5}"/>
                </a:ext>
              </a:extLst>
            </p:cNvPr>
            <p:cNvSpPr txBox="1"/>
            <p:nvPr/>
          </p:nvSpPr>
          <p:spPr>
            <a:xfrm>
              <a:off x="8336162" y="2994478"/>
              <a:ext cx="563147" cy="6647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714" dirty="0"/>
                <a:t>4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79BE405-BEA4-951E-19C6-8797819F1806}"/>
                </a:ext>
              </a:extLst>
            </p:cNvPr>
            <p:cNvSpPr txBox="1"/>
            <p:nvPr/>
          </p:nvSpPr>
          <p:spPr>
            <a:xfrm>
              <a:off x="5206892" y="2076646"/>
              <a:ext cx="4495705" cy="1157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714" dirty="0"/>
                <a:t>Supplementary Movie 4</a:t>
              </a:r>
            </a:p>
            <a:p>
              <a:pPr algn="ctr"/>
              <a:r>
                <a:rPr lang="en-US" sz="1714" dirty="0"/>
                <a:t>FD hiPSC-VC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133131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8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55</Words>
  <Application>Microsoft Office PowerPoint</Application>
  <PresentationFormat>Widescreen</PresentationFormat>
  <Paragraphs>34</Paragraphs>
  <Slides>2</Slides>
  <Notes>2</Notes>
  <HiddenSlides>0</HiddenSlides>
  <MMClips>4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</vt:vector>
  </TitlesOfParts>
  <Company>Michigan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onteiro Da Rocha, Andre</dc:creator>
  <cp:lastModifiedBy>Monteiro Da Rocha, Andre</cp:lastModifiedBy>
  <cp:revision>3</cp:revision>
  <dcterms:created xsi:type="dcterms:W3CDTF">2026-02-18T21:14:01Z</dcterms:created>
  <dcterms:modified xsi:type="dcterms:W3CDTF">2026-02-18T21:46:55Z</dcterms:modified>
</cp:coreProperties>
</file>